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7077075" cy="93853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77600" cy="938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-360"/>
            <a:ext cx="3068640" cy="469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080" bIns="460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006800" y="-360"/>
            <a:ext cx="3068640" cy="469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080" bIns="460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19040" y="703440"/>
            <a:ext cx="2639880" cy="3519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2520" rIns="9252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7760" y="4457880"/>
            <a:ext cx="5661000" cy="422424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080" bIns="460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8913600"/>
            <a:ext cx="3068640" cy="469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080" bIns="4608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006800" y="8913600"/>
            <a:ext cx="3068640" cy="469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080" bIns="46080" anchor="b">
            <a:noAutofit/>
          </a:bodyPr>
          <a:lstStyle>
            <a:lvl1pPr indent="0" algn="r">
              <a:buNone/>
              <a:tabLst>
                <a:tab algn="l" pos="0"/>
                <a:tab algn="l" pos="923760"/>
                <a:tab algn="l" pos="1847880"/>
                <a:tab algn="l" pos="2771640"/>
                <a:tab algn="l" pos="3695760"/>
                <a:tab algn="l" pos="4619520"/>
                <a:tab algn="l" pos="5543640"/>
                <a:tab algn="l" pos="6467400"/>
                <a:tab algn="l" pos="7391520"/>
                <a:tab algn="l" pos="8315280"/>
                <a:tab algn="l" pos="9239400"/>
                <a:tab algn="l" pos="1016316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23760"/>
                <a:tab algn="l" pos="1847880"/>
                <a:tab algn="l" pos="2771640"/>
                <a:tab algn="l" pos="3695760"/>
                <a:tab algn="l" pos="4619520"/>
                <a:tab algn="l" pos="5543640"/>
                <a:tab algn="l" pos="6467400"/>
                <a:tab algn="l" pos="7391520"/>
                <a:tab algn="l" pos="8315280"/>
                <a:tab algn="l" pos="9239400"/>
                <a:tab algn="l" pos="10163160"/>
              </a:tabLst>
            </a:pPr>
            <a:fld id="{5698CAE9-8C15-4E63-BF67-C6E5FFB482DA}" type="slidenum"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Rectangle 7"/>
          <p:cNvSpPr/>
          <p:nvPr/>
        </p:nvSpPr>
        <p:spPr>
          <a:xfrm>
            <a:off x="4006800" y="8913960"/>
            <a:ext cx="3068640" cy="46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46080" bIns="46080" anchor="b">
            <a:noAutofit/>
          </a:bodyPr>
          <a:p>
            <a:pPr algn="r">
              <a:tabLst>
                <a:tab algn="l" pos="0"/>
                <a:tab algn="l" pos="923760"/>
                <a:tab algn="l" pos="1847880"/>
                <a:tab algn="l" pos="2771640"/>
                <a:tab algn="l" pos="3695760"/>
                <a:tab algn="l" pos="4619520"/>
                <a:tab algn="l" pos="5543640"/>
                <a:tab algn="l" pos="6467400"/>
                <a:tab algn="l" pos="7391520"/>
                <a:tab algn="l" pos="8315280"/>
                <a:tab algn="l" pos="9239400"/>
                <a:tab algn="l" pos="10163160"/>
              </a:tabLst>
            </a:pPr>
            <a:fld id="{A33CAD1D-3C56-41FF-BE63-D652E2A1E4F6}" type="slidenum"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PlaceHolder 1"/>
          <p:cNvSpPr>
            <a:spLocks noGrp="1"/>
          </p:cNvSpPr>
          <p:nvPr>
            <p:ph type="sldImg"/>
          </p:nvPr>
        </p:nvSpPr>
        <p:spPr>
          <a:xfrm>
            <a:off x="2219400" y="703440"/>
            <a:ext cx="2639880" cy="3519360"/>
          </a:xfrm>
          <a:prstGeom prst="rect">
            <a:avLst/>
          </a:prstGeom>
          <a:ln w="0">
            <a:noFill/>
          </a:ln>
        </p:spPr>
      </p:sp>
      <p:sp>
        <p:nvSpPr>
          <p:cNvPr id="98" name="PlaceHolder 2"/>
          <p:cNvSpPr>
            <a:spLocks noGrp="1"/>
          </p:cNvSpPr>
          <p:nvPr>
            <p:ph type="body"/>
          </p:nvPr>
        </p:nvSpPr>
        <p:spPr>
          <a:xfrm>
            <a:off x="707760" y="4457880"/>
            <a:ext cx="5661000" cy="4224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D64D4B-9DD8-489F-A98B-413F7A75E9C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20CF43-EA04-4FC1-8D55-DE4EAFDAB5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071865-0FB8-4500-89D2-2A0F0DF3CDE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D9DC48-29EA-4F6F-A516-31EB3E5E36C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AC97E2-C3B8-4809-8CCA-5C8A08CF04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80A132-9B5B-42C6-BD28-52A71E24609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CDB05C-5929-42CE-84F4-F9C5EE4645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283092-6D5A-42A1-B1B2-AE695CFEFD8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B45285-2B66-4C77-80E7-8BAB64EB391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6B0EDF-BE40-48AB-8F4A-46E3BA55A5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3BE36B-229E-4324-82C7-6EE73D007F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57C068-7F79-4DE3-AE0E-7B896D873F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BDCC5D3-59AD-4C3C-94D0-E5BF67613A78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1178"/>
          <p:cNvSpPr/>
          <p:nvPr/>
        </p:nvSpPr>
        <p:spPr>
          <a:xfrm>
            <a:off x="423720" y="501480"/>
            <a:ext cx="5911920" cy="11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Figure S1 - Molecular dating of divergence time for several solanaceous species  The previously published dataset [2] were used to reconstruct the maximum-likelihood tree, and the divergence time was estimated using non-parametric rate smoothing method (see Methods).  The calibration point was 86MYA for tomato-coffee split [14]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9" name="Group 49"/>
          <p:cNvGrpSpPr/>
          <p:nvPr/>
        </p:nvGrpSpPr>
        <p:grpSpPr>
          <a:xfrm>
            <a:off x="537840" y="2581200"/>
            <a:ext cx="5657760" cy="5386320"/>
            <a:chOff x="537840" y="2581200"/>
            <a:chExt cx="5657760" cy="5386320"/>
          </a:xfrm>
        </p:grpSpPr>
        <p:grpSp>
          <p:nvGrpSpPr>
            <p:cNvPr id="50" name="Group 48"/>
            <p:cNvGrpSpPr/>
            <p:nvPr/>
          </p:nvGrpSpPr>
          <p:grpSpPr>
            <a:xfrm>
              <a:off x="3960360" y="2581200"/>
              <a:ext cx="2235240" cy="5353560"/>
              <a:chOff x="3960360" y="2581200"/>
              <a:chExt cx="2235240" cy="5353560"/>
            </a:xfrm>
          </p:grpSpPr>
          <p:sp>
            <p:nvSpPr>
              <p:cNvPr id="51" name="Rectangle 46"/>
              <p:cNvSpPr/>
              <p:nvPr/>
            </p:nvSpPr>
            <p:spPr>
              <a:xfrm>
                <a:off x="3969720" y="2581200"/>
                <a:ext cx="17244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S. lycopersicum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 TA209 (tomato)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2" name="Rectangle 48"/>
              <p:cNvSpPr/>
              <p:nvPr/>
            </p:nvSpPr>
            <p:spPr>
              <a:xfrm>
                <a:off x="3966840" y="3323880"/>
                <a:ext cx="16192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S. tuberosum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 TA3427 (potato)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3" name="Rectangle 52"/>
              <p:cNvSpPr/>
              <p:nvPr/>
            </p:nvSpPr>
            <p:spPr>
              <a:xfrm>
                <a:off x="3960360" y="4066920"/>
                <a:ext cx="176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S. melongena 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TA2986 (eggplant)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4" name="Rectangle 56"/>
              <p:cNvSpPr/>
              <p:nvPr/>
            </p:nvSpPr>
            <p:spPr>
              <a:xfrm>
                <a:off x="3967560" y="4809960"/>
                <a:ext cx="1551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C. annuum 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TA3417 (pepper)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5" name="Rectangle 58"/>
              <p:cNvSpPr/>
              <p:nvPr/>
            </p:nvSpPr>
            <p:spPr>
              <a:xfrm>
                <a:off x="3965760" y="5553000"/>
                <a:ext cx="1153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Physalis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 spp. TA1367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6" name="Rectangle 64"/>
              <p:cNvSpPr/>
              <p:nvPr/>
            </p:nvSpPr>
            <p:spPr>
              <a:xfrm>
                <a:off x="3978360" y="7039080"/>
                <a:ext cx="1968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P. axillaris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 </a:t>
                </a:r>
                <a:r>
                  <a:rPr b="1" i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parodii 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TA3310 (petunia)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7" name="Rectangle 66"/>
              <p:cNvSpPr/>
              <p:nvPr/>
            </p:nvSpPr>
            <p:spPr>
              <a:xfrm>
                <a:off x="3995280" y="6296040"/>
                <a:ext cx="20977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N. tomentosiformis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 TA3349 (</a:t>
                </a:r>
                <a:r>
                  <a:rPr b="1" i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Nicotiana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)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8" name="Rectangle 72"/>
              <p:cNvSpPr/>
              <p:nvPr/>
            </p:nvSpPr>
            <p:spPr>
              <a:xfrm>
                <a:off x="3971160" y="7782120"/>
                <a:ext cx="22244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C. canephora 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var. robusta BP409 (coffee)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59" name="Group 47"/>
            <p:cNvGrpSpPr/>
            <p:nvPr/>
          </p:nvGrpSpPr>
          <p:grpSpPr>
            <a:xfrm>
              <a:off x="537840" y="2649240"/>
              <a:ext cx="3356640" cy="5318280"/>
              <a:chOff x="537840" y="2649240"/>
              <a:chExt cx="3356640" cy="5318280"/>
            </a:xfrm>
          </p:grpSpPr>
          <p:sp>
            <p:nvSpPr>
              <p:cNvPr id="60" name="Line 43"/>
              <p:cNvSpPr/>
              <p:nvPr/>
            </p:nvSpPr>
            <p:spPr>
              <a:xfrm>
                <a:off x="816120" y="4993920"/>
                <a:ext cx="849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1" name="Rectangle 44"/>
              <p:cNvSpPr/>
              <p:nvPr/>
            </p:nvSpPr>
            <p:spPr>
              <a:xfrm>
                <a:off x="715320" y="4816080"/>
                <a:ext cx="294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1MYA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2" name="Line 45"/>
              <p:cNvSpPr/>
              <p:nvPr/>
            </p:nvSpPr>
            <p:spPr>
              <a:xfrm flipH="1">
                <a:off x="3260880" y="2649240"/>
                <a:ext cx="6332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3" name="Line 47"/>
              <p:cNvSpPr/>
              <p:nvPr/>
            </p:nvSpPr>
            <p:spPr>
              <a:xfrm flipH="1">
                <a:off x="3260880" y="3391920"/>
                <a:ext cx="6332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4" name="Line 49"/>
              <p:cNvSpPr/>
              <p:nvPr/>
            </p:nvSpPr>
            <p:spPr>
              <a:xfrm flipH="1">
                <a:off x="2550240" y="3020400"/>
                <a:ext cx="7102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5" name="Line 50"/>
              <p:cNvSpPr/>
              <p:nvPr/>
            </p:nvSpPr>
            <p:spPr>
              <a:xfrm>
                <a:off x="3261240" y="2649240"/>
                <a:ext cx="720" cy="7426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6" name="Line 51"/>
              <p:cNvSpPr/>
              <p:nvPr/>
            </p:nvSpPr>
            <p:spPr>
              <a:xfrm flipH="1">
                <a:off x="2550240" y="4134960"/>
                <a:ext cx="13438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7" name="Line 53"/>
              <p:cNvSpPr/>
              <p:nvPr/>
            </p:nvSpPr>
            <p:spPr>
              <a:xfrm flipH="1">
                <a:off x="2194920" y="3577680"/>
                <a:ext cx="3556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8" name="Line 54"/>
              <p:cNvSpPr/>
              <p:nvPr/>
            </p:nvSpPr>
            <p:spPr>
              <a:xfrm>
                <a:off x="2550600" y="3020400"/>
                <a:ext cx="720" cy="11142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9" name="Line 55"/>
              <p:cNvSpPr/>
              <p:nvPr/>
            </p:nvSpPr>
            <p:spPr>
              <a:xfrm flipH="1">
                <a:off x="2523600" y="4878000"/>
                <a:ext cx="13708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0" name="Line 57"/>
              <p:cNvSpPr/>
              <p:nvPr/>
            </p:nvSpPr>
            <p:spPr>
              <a:xfrm flipH="1">
                <a:off x="2523600" y="5621040"/>
                <a:ext cx="13708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1" name="Line 59"/>
              <p:cNvSpPr/>
              <p:nvPr/>
            </p:nvSpPr>
            <p:spPr>
              <a:xfrm flipH="1">
                <a:off x="2194560" y="5249520"/>
                <a:ext cx="3286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2" name="Line 60"/>
              <p:cNvSpPr/>
              <p:nvPr/>
            </p:nvSpPr>
            <p:spPr>
              <a:xfrm>
                <a:off x="2523600" y="4878000"/>
                <a:ext cx="720" cy="7426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3" name="Line 61"/>
              <p:cNvSpPr/>
              <p:nvPr/>
            </p:nvSpPr>
            <p:spPr>
              <a:xfrm flipH="1">
                <a:off x="1837800" y="4412880"/>
                <a:ext cx="3567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4" name="Line 62"/>
              <p:cNvSpPr/>
              <p:nvPr/>
            </p:nvSpPr>
            <p:spPr>
              <a:xfrm>
                <a:off x="2194920" y="3577680"/>
                <a:ext cx="720" cy="16714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5" name="Line 63"/>
              <p:cNvSpPr/>
              <p:nvPr/>
            </p:nvSpPr>
            <p:spPr>
              <a:xfrm flipH="1">
                <a:off x="2514240" y="6364080"/>
                <a:ext cx="13802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6" name="Line 65"/>
              <p:cNvSpPr/>
              <p:nvPr/>
            </p:nvSpPr>
            <p:spPr>
              <a:xfrm flipH="1">
                <a:off x="2514240" y="7107120"/>
                <a:ext cx="13802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7" name="Line 67"/>
              <p:cNvSpPr/>
              <p:nvPr/>
            </p:nvSpPr>
            <p:spPr>
              <a:xfrm flipH="1">
                <a:off x="1838160" y="6735600"/>
                <a:ext cx="6760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8" name="Line 68"/>
              <p:cNvSpPr/>
              <p:nvPr/>
            </p:nvSpPr>
            <p:spPr>
              <a:xfrm>
                <a:off x="2514240" y="6364080"/>
                <a:ext cx="720" cy="7426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9" name="Line 69"/>
              <p:cNvSpPr/>
              <p:nvPr/>
            </p:nvSpPr>
            <p:spPr>
              <a:xfrm flipH="1">
                <a:off x="604080" y="5574960"/>
                <a:ext cx="539640" cy="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0" name="Line 70"/>
              <p:cNvSpPr/>
              <p:nvPr/>
            </p:nvSpPr>
            <p:spPr>
              <a:xfrm>
                <a:off x="1838160" y="4412880"/>
                <a:ext cx="720" cy="23227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1" name="Line 71"/>
              <p:cNvSpPr/>
              <p:nvPr/>
            </p:nvSpPr>
            <p:spPr>
              <a:xfrm flipH="1">
                <a:off x="600120" y="7850160"/>
                <a:ext cx="16891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2" name="Line 73"/>
              <p:cNvSpPr/>
              <p:nvPr/>
            </p:nvSpPr>
            <p:spPr>
              <a:xfrm>
                <a:off x="599040" y="5587920"/>
                <a:ext cx="720" cy="22622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3" name="Line 69"/>
              <p:cNvSpPr/>
              <p:nvPr/>
            </p:nvSpPr>
            <p:spPr>
              <a:xfrm flipH="1">
                <a:off x="1284120" y="5574960"/>
                <a:ext cx="539640" cy="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4" name="Line 71"/>
              <p:cNvSpPr/>
              <p:nvPr/>
            </p:nvSpPr>
            <p:spPr>
              <a:xfrm flipH="1">
                <a:off x="2395440" y="7850160"/>
                <a:ext cx="14914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5" name="TextBox 567"/>
              <p:cNvSpPr/>
              <p:nvPr/>
            </p:nvSpPr>
            <p:spPr>
              <a:xfrm>
                <a:off x="3179520" y="2906280"/>
                <a:ext cx="340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7.3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6" name="TextBox 568"/>
              <p:cNvSpPr/>
              <p:nvPr/>
            </p:nvSpPr>
            <p:spPr>
              <a:xfrm>
                <a:off x="2450160" y="3482640"/>
                <a:ext cx="404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15.5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7" name="TextBox 569"/>
              <p:cNvSpPr/>
              <p:nvPr/>
            </p:nvSpPr>
            <p:spPr>
              <a:xfrm>
                <a:off x="2436840" y="5136840"/>
                <a:ext cx="404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15.8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8" name="TextBox 570"/>
              <p:cNvSpPr/>
              <p:nvPr/>
            </p:nvSpPr>
            <p:spPr>
              <a:xfrm>
                <a:off x="2100600" y="4298760"/>
                <a:ext cx="404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19.6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9" name="TextBox 571"/>
              <p:cNvSpPr/>
              <p:nvPr/>
            </p:nvSpPr>
            <p:spPr>
              <a:xfrm>
                <a:off x="2414880" y="6640560"/>
                <a:ext cx="404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15.9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0" name="TextBox 572"/>
              <p:cNvSpPr/>
              <p:nvPr/>
            </p:nvSpPr>
            <p:spPr>
              <a:xfrm>
                <a:off x="1744560" y="5475240"/>
                <a:ext cx="404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23.7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1" name="TextBox 573"/>
              <p:cNvSpPr/>
              <p:nvPr/>
            </p:nvSpPr>
            <p:spPr>
              <a:xfrm>
                <a:off x="537840" y="6629400"/>
                <a:ext cx="3088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</a:rPr>
                  <a:t>86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2" name="Straight Connector 576"/>
              <p:cNvSpPr/>
              <p:nvPr/>
            </p:nvSpPr>
            <p:spPr>
              <a:xfrm flipH="1">
                <a:off x="1084680" y="5464080"/>
                <a:ext cx="99720" cy="228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3" name="Straight Connector 577"/>
              <p:cNvSpPr/>
              <p:nvPr/>
            </p:nvSpPr>
            <p:spPr>
              <a:xfrm flipH="1">
                <a:off x="1226880" y="5464080"/>
                <a:ext cx="99720" cy="228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4" name="Straight Connector 578"/>
              <p:cNvSpPr/>
              <p:nvPr/>
            </p:nvSpPr>
            <p:spPr>
              <a:xfrm flipH="1">
                <a:off x="2240280" y="7738920"/>
                <a:ext cx="99720" cy="228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5" name="Straight Connector 579"/>
              <p:cNvSpPr/>
              <p:nvPr/>
            </p:nvSpPr>
            <p:spPr>
              <a:xfrm flipH="1">
                <a:off x="2340000" y="7738920"/>
                <a:ext cx="99720" cy="228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5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12T09:36:29Z</dcterms:created>
  <dc:creator>Feinan</dc:creator>
  <dc:description/>
  <dc:language>en-US</dc:language>
  <cp:lastModifiedBy>Feinan</cp:lastModifiedBy>
  <dcterms:modified xsi:type="dcterms:W3CDTF">2010-01-12T19:47:35Z</dcterms:modified>
  <cp:revision>294</cp:revision>
  <dc:subject/>
  <dc:title>PowerPoint Presentation</dc:title>
</cp:coreProperties>
</file>